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93" d="100"/>
          <a:sy n="93" d="100"/>
        </p:scale>
        <p:origin x="-1176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F584D-93E9-3B4B-97EF-D490ADA515FC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C33B3-BDC1-5E40-B9C5-28011EAD8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665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F584D-93E9-3B4B-97EF-D490ADA515FC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C33B3-BDC1-5E40-B9C5-28011EAD8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996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F584D-93E9-3B4B-97EF-D490ADA515FC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C33B3-BDC1-5E40-B9C5-28011EAD8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711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F584D-93E9-3B4B-97EF-D490ADA515FC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C33B3-BDC1-5E40-B9C5-28011EAD8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784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F584D-93E9-3B4B-97EF-D490ADA515FC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C33B3-BDC1-5E40-B9C5-28011EAD8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944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F584D-93E9-3B4B-97EF-D490ADA515FC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C33B3-BDC1-5E40-B9C5-28011EAD8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696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F584D-93E9-3B4B-97EF-D490ADA515FC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C33B3-BDC1-5E40-B9C5-28011EAD8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438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F584D-93E9-3B4B-97EF-D490ADA515FC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C33B3-BDC1-5E40-B9C5-28011EAD8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1105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F584D-93E9-3B4B-97EF-D490ADA515FC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C33B3-BDC1-5E40-B9C5-28011EAD8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217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F584D-93E9-3B4B-97EF-D490ADA515FC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C33B3-BDC1-5E40-B9C5-28011EAD8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09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F584D-93E9-3B4B-97EF-D490ADA515FC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C33B3-BDC1-5E40-B9C5-28011EAD8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977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8F584D-93E9-3B4B-97EF-D490ADA515FC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CC33B3-BDC1-5E40-B9C5-28011EAD8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322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4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2B img101 pY-STAT3.jpg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80599" y="1275300"/>
            <a:ext cx="2245493" cy="1620000"/>
          </a:xfrm>
          <a:prstGeom prst="rect">
            <a:avLst/>
          </a:prstGeom>
        </p:spPr>
      </p:pic>
      <p:pic>
        <p:nvPicPr>
          <p:cNvPr id="3" name="Picture 2" descr="2B img102 STAT3.jpg"/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79997" y="3734626"/>
            <a:ext cx="2146095" cy="1620000"/>
          </a:xfrm>
          <a:prstGeom prst="rect">
            <a:avLst/>
          </a:prstGeom>
        </p:spPr>
      </p:pic>
      <p:pic>
        <p:nvPicPr>
          <p:cNvPr id="4" name="Picture 3" descr="2B img103 Tubulin.jpg"/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79997" y="6074220"/>
            <a:ext cx="2146095" cy="162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04957" y="742782"/>
            <a:ext cx="890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 2B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456760" y="1861023"/>
            <a:ext cx="979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pY-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392732" y="1772348"/>
            <a:ext cx="2233359" cy="548626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4649522" y="1824961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787879" y="4273493"/>
            <a:ext cx="716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2479997" y="4242176"/>
            <a:ext cx="2144642" cy="396452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4624639" y="4299363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97021" y="4850599"/>
            <a:ext cx="14164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>
                <a:latin typeface="Arial"/>
                <a:cs typeface="Arial"/>
              </a:rPr>
              <a:t>Non-specific band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3" name="Isosceles Triangle 12"/>
          <p:cNvSpPr/>
          <p:nvPr/>
        </p:nvSpPr>
        <p:spPr>
          <a:xfrm rot="5400000">
            <a:off x="2295027" y="4917098"/>
            <a:ext cx="144000" cy="144000"/>
          </a:xfrm>
          <a:prstGeom prst="triangle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1559976" y="6973074"/>
            <a:ext cx="939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Arial"/>
                <a:cs typeface="Arial"/>
              </a:rPr>
              <a:t>-Tubulin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2479997" y="6948491"/>
            <a:ext cx="2140867" cy="40195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4624639" y="7007362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5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63297" y="6665297"/>
            <a:ext cx="716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541969" y="998301"/>
            <a:ext cx="87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W (</a:t>
            </a:r>
            <a:r>
              <a:rPr lang="en-US" sz="1200" dirty="0" err="1" smtClean="0">
                <a:latin typeface="Arial"/>
                <a:cs typeface="Arial"/>
              </a:rPr>
              <a:t>kDa</a:t>
            </a:r>
            <a:r>
              <a:rPr lang="en-US" sz="1200" dirty="0" smtClean="0">
                <a:latin typeface="Arial"/>
                <a:cs typeface="Arial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2995500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2D pY-STAT3.tif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99374" y="1215635"/>
            <a:ext cx="1265423" cy="19786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85262" y="558116"/>
            <a:ext cx="890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 2D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3" name="Picture 2" descr="2D film 4 iNOS.tif"/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84081" y="3806150"/>
            <a:ext cx="1215572" cy="1780032"/>
          </a:xfrm>
          <a:prstGeom prst="rect">
            <a:avLst/>
          </a:prstGeom>
        </p:spPr>
      </p:pic>
      <p:pic>
        <p:nvPicPr>
          <p:cNvPr id="5" name="Picture 4" descr="2D film 4 STAT3.tif"/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45474" y="6298785"/>
            <a:ext cx="1298367" cy="1780032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2300883" y="4085485"/>
            <a:ext cx="613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err="1" smtClean="0">
                <a:latin typeface="Arial"/>
                <a:cs typeface="Arial"/>
              </a:rPr>
              <a:t>iNOS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884081" y="4085484"/>
            <a:ext cx="1220031" cy="307777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4116220" y="4100874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13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140636" y="6903527"/>
            <a:ext cx="716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2829415" y="6903527"/>
            <a:ext cx="1331999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4184849" y="6903527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</a:p>
        </p:txBody>
      </p:sp>
      <p:sp>
        <p:nvSpPr>
          <p:cNvPr id="23" name="Rectangle 22"/>
          <p:cNvSpPr/>
          <p:nvPr/>
        </p:nvSpPr>
        <p:spPr>
          <a:xfrm>
            <a:off x="2857706" y="7361108"/>
            <a:ext cx="1267585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/>
          <p:cNvSpPr txBox="1"/>
          <p:nvPr/>
        </p:nvSpPr>
        <p:spPr>
          <a:xfrm>
            <a:off x="1711444" y="4913030"/>
            <a:ext cx="11860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Arial"/>
                <a:cs typeface="Arial"/>
              </a:rPr>
              <a:t>-Tubulin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159013" y="4932278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5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671299" y="7426152"/>
            <a:ext cx="11860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Arial"/>
                <a:cs typeface="Arial"/>
              </a:rPr>
              <a:t>-Tubulin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184849" y="7445400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5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819061" y="1881648"/>
            <a:ext cx="979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pY-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2803017" y="1854911"/>
            <a:ext cx="1273325" cy="43492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/>
          <p:cNvSpPr txBox="1"/>
          <p:nvPr/>
        </p:nvSpPr>
        <p:spPr>
          <a:xfrm>
            <a:off x="4172783" y="1881648"/>
            <a:ext cx="61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9, 86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076343" y="788948"/>
            <a:ext cx="87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W (</a:t>
            </a:r>
            <a:r>
              <a:rPr lang="en-US" sz="1200" dirty="0" err="1" smtClean="0">
                <a:latin typeface="Arial"/>
                <a:cs typeface="Arial"/>
              </a:rPr>
              <a:t>kDa</a:t>
            </a:r>
            <a:r>
              <a:rPr lang="en-US" sz="1200" dirty="0" smtClean="0">
                <a:latin typeface="Arial"/>
                <a:cs typeface="Arial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852204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51</Words>
  <Application>Microsoft Macintosh PowerPoint</Application>
  <PresentationFormat>Letter Paper (8.5x11 in)</PresentationFormat>
  <Paragraphs>2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Ma</dc:creator>
  <cp:lastModifiedBy>Jennifer Ma</cp:lastModifiedBy>
  <cp:revision>1</cp:revision>
  <dcterms:created xsi:type="dcterms:W3CDTF">2017-02-06T16:57:54Z</dcterms:created>
  <dcterms:modified xsi:type="dcterms:W3CDTF">2017-02-06T17:04:39Z</dcterms:modified>
</cp:coreProperties>
</file>